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66" r:id="rId2"/>
    <p:sldId id="268" r:id="rId3"/>
    <p:sldId id="261" r:id="rId4"/>
    <p:sldId id="277" r:id="rId5"/>
    <p:sldId id="272" r:id="rId6"/>
    <p:sldId id="273" r:id="rId7"/>
    <p:sldId id="274" r:id="rId8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602A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3" autoAdjust="0"/>
    <p:restoredTop sz="74490" autoAdjust="0"/>
  </p:normalViewPr>
  <p:slideViewPr>
    <p:cSldViewPr snapToGrid="0">
      <p:cViewPr varScale="1">
        <p:scale>
          <a:sx n="70" d="100"/>
          <a:sy n="70" d="100"/>
        </p:scale>
        <p:origin x="34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B040F3-7B0A-4C7F-B5AF-70297A5B4E04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0DC454-9FC8-47F6-A969-2381404424F5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31876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0DC454-9FC8-47F6-A969-2381404424F5}" type="slidenum">
              <a:rPr lang="en-DE" smtClean="0"/>
              <a:t>1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224014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0DC454-9FC8-47F6-A969-2381404424F5}" type="slidenum">
              <a:rPr lang="en-DE" smtClean="0"/>
              <a:t>2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552011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0DC454-9FC8-47F6-A969-2381404424F5}" type="slidenum">
              <a:rPr lang="en-DE" smtClean="0"/>
              <a:t>3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170682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0DC454-9FC8-47F6-A969-2381404424F5}" type="slidenum">
              <a:rPr lang="en-DE" smtClean="0"/>
              <a:t>4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0355984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0DC454-9FC8-47F6-A969-2381404424F5}" type="slidenum">
              <a:rPr lang="en-DE" smtClean="0"/>
              <a:t>5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9522612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0DC454-9FC8-47F6-A969-2381404424F5}" type="slidenum">
              <a:rPr lang="en-DE" smtClean="0"/>
              <a:t>6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181183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0DC454-9FC8-47F6-A969-2381404424F5}" type="slidenum">
              <a:rPr lang="en-DE" smtClean="0"/>
              <a:t>7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998213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40693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012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868722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21367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17899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47007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58016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4417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01784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09240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37513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098274-4B75-437A-B808-000CCF276B67}" type="datetimeFigureOut">
              <a:rPr lang="en-DE" smtClean="0"/>
              <a:t>26.04.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26AE2-82E0-4A6C-82D3-10F0C3300BF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51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54E51FA-0F1D-5753-0169-8F8AF81DC5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92" y="0"/>
            <a:ext cx="6754953" cy="816934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02EEBF0-E418-C856-750D-A2F411579312}"/>
              </a:ext>
            </a:extLst>
          </p:cNvPr>
          <p:cNvSpPr txBox="1"/>
          <p:nvPr/>
        </p:nvSpPr>
        <p:spPr>
          <a:xfrm>
            <a:off x="3619705" y="5734239"/>
            <a:ext cx="3113604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Final lentiviral plasmid design and antibiotic kill curves.  A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ntiviral plasmid design of </a:t>
            </a:r>
          </a:p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Lenti_EF1a-rtTA_BsdR with the regions of interest in the gray box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Un-transduced hiPSCs were used to determine the optimal concentration of Blasticidin needed to select for successfully transduced cells and 1.0 µg/mL of Blasticidin S HCl for five days was chosen.  </a:t>
            </a:r>
          </a:p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entiviral plasmid design of </a:t>
            </a:r>
          </a:p>
          <a:p>
            <a:pPr algn="just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Lenti_TRE-NPM_Hyg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ith the regions of interest in the gray box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Un-transduced hiPSCs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iPSCs with </a:t>
            </a:r>
          </a:p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Lenti_EF1a-rtTA_BsdR were used to determine the optimal concentration of HygromycinB needed to select for successfully transduced cells and 25.0 µg/mL of HygromycinB for six days was chosen.</a:t>
            </a:r>
            <a:endParaRPr lang="en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02300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14894A7-CDBF-611B-7471-4511759540B0}"/>
              </a:ext>
            </a:extLst>
          </p:cNvPr>
          <p:cNvSpPr txBox="1"/>
          <p:nvPr/>
        </p:nvSpPr>
        <p:spPr>
          <a:xfrm>
            <a:off x="195208" y="2827052"/>
            <a:ext cx="628778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Gene expression analysis of rtTA and semi-quantification of marker expression of the markers of interest in cells cultured for five days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A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 expression analysis of un-transduced and transduced hiPSCs for rtTA relative to un-transduced,  normalized to GAPDH levels. Unpaired t-test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N = 3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*** p </a:t>
            </a:r>
            <a:r>
              <a:rPr lang="en-DE" sz="1100" dirty="0">
                <a:latin typeface="Arial" panose="020B0604020202020204" pitchFamily="34" charset="0"/>
                <a:cs typeface="Arial" panose="020B0604020202020204" pitchFamily="34" charset="0"/>
              </a:rPr>
              <a:t>≤ 0.0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emi-quantification analysis using GVI of the protein expression of the markers of interest in cells cultured with and without DOX for five days, normalized to DAPI counts. Unpaired t-test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N = 3, n ≥ 9)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** p </a:t>
            </a:r>
            <a:r>
              <a:rPr lang="en-DE" sz="1100" dirty="0">
                <a:latin typeface="Arial" panose="020B0604020202020204" pitchFamily="34" charset="0"/>
                <a:cs typeface="Arial" panose="020B0604020202020204" pitchFamily="34" charset="0"/>
              </a:rPr>
              <a:t>≤ 0.0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1.  Error bars represent standard deviation. </a:t>
            </a:r>
            <a:endParaRPr lang="en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66006BC-8487-433D-BA9C-39E2552492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7841" y="0"/>
            <a:ext cx="6437934" cy="2877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03483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D2DDD68C-9B67-1D5F-ABB5-E301D569EAF3}"/>
              </a:ext>
            </a:extLst>
          </p:cNvPr>
          <p:cNvSpPr txBox="1"/>
          <p:nvPr/>
        </p:nvSpPr>
        <p:spPr>
          <a:xfrm>
            <a:off x="150969" y="5335748"/>
            <a:ext cx="640421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Gene expression and semi-quantification of marker expression of cells cultured for ten days.  A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 expression of the markers of interest after ten days of culture with and without DOX.  All values relative to day 0 at the stem cell stage and normalized to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paired t-test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N = 3)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 p </a:t>
            </a:r>
            <a:r>
              <a:rPr lang="en-DE" sz="1100" dirty="0">
                <a:latin typeface="Arial" panose="020B0604020202020204" pitchFamily="34" charset="0"/>
                <a:cs typeface="Arial" panose="020B0604020202020204" pitchFamily="34" charset="0"/>
              </a:rPr>
              <a:t>≤ 0.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emi-quantification analysis using GVI of the protein expression of the markers of interest in cells cultured with and without DOX for ten days, normalized to DAPI counts.  Unpaired t-test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N = 3, n ≥ 9)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** p </a:t>
            </a:r>
            <a:r>
              <a:rPr lang="en-DE" sz="1100" dirty="0">
                <a:latin typeface="Arial" panose="020B0604020202020204" pitchFamily="34" charset="0"/>
                <a:cs typeface="Arial" panose="020B0604020202020204" pitchFamily="34" charset="0"/>
              </a:rPr>
              <a:t>≤ 0.0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1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ynamic GSIS results: amount of insulin secreted upon consecutive stimulation with 2 mM, 20 mM, and again 2 mM glucose normalized to cell count. Unpaired t-test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N = 3, n = 18),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* p </a:t>
            </a:r>
            <a:r>
              <a:rPr lang="en-DE" sz="1100" dirty="0">
                <a:latin typeface="Arial" panose="020B0604020202020204" pitchFamily="34" charset="0"/>
                <a:cs typeface="Arial" panose="020B0604020202020204" pitchFamily="34" charset="0"/>
              </a:rPr>
              <a:t>≤ 0.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, **** p </a:t>
            </a:r>
            <a:r>
              <a:rPr lang="en-DE" sz="1100" dirty="0">
                <a:latin typeface="Arial" panose="020B0604020202020204" pitchFamily="34" charset="0"/>
                <a:cs typeface="Arial" panose="020B0604020202020204" pitchFamily="34" charset="0"/>
              </a:rPr>
              <a:t>≤ 0.0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1. Error bars represent standard deviation. </a:t>
            </a:r>
            <a:endParaRPr lang="en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F0A252E-E77F-82D2-FD0C-622B0AA7AC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336" y="0"/>
            <a:ext cx="6736664" cy="5584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50448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D2DDD68C-9B67-1D5F-ABB5-E301D569EAF3}"/>
              </a:ext>
            </a:extLst>
          </p:cNvPr>
          <p:cNvSpPr txBox="1"/>
          <p:nvPr/>
        </p:nvSpPr>
        <p:spPr>
          <a:xfrm>
            <a:off x="211929" y="3128996"/>
            <a:ext cx="640421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Parallel GSIS results of donor human islets.  A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rallel GSIS results of human donor islets: amount of insulin secreted upon stimulation with 2 mM and 20 mM glucose normalized to the insulin content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GSIS index as represented by the fold change in insulin secretion between the 2 mM and 20 mM glucose challenges.  Solid line at 1 represents the threshold needed to be considered a functional response. Unpaired t-test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n = 8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Error bars represent standard deviation. </a:t>
            </a:r>
            <a:endParaRPr lang="en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06FC86B-2429-F2C7-DA9D-5A1FB8EFCF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993" y="0"/>
            <a:ext cx="6248942" cy="3237257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2E8B72D7-BEBE-C8EC-03A7-74815E150738}"/>
              </a:ext>
            </a:extLst>
          </p:cNvPr>
          <p:cNvSpPr/>
          <p:nvPr/>
        </p:nvSpPr>
        <p:spPr>
          <a:xfrm>
            <a:off x="97536" y="73152"/>
            <a:ext cx="6656832" cy="4181856"/>
          </a:xfrm>
          <a:prstGeom prst="rect">
            <a:avLst/>
          </a:prstGeom>
          <a:noFill/>
          <a:ln w="7620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46581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672E0D7-A0B9-C6FE-ED53-EED53DF2E0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7485168"/>
              </p:ext>
            </p:extLst>
          </p:nvPr>
        </p:nvGraphicFramePr>
        <p:xfrm>
          <a:off x="300520" y="428091"/>
          <a:ext cx="6120828" cy="5588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8992">
                  <a:extLst>
                    <a:ext uri="{9D8B030D-6E8A-4147-A177-3AD203B41FA5}">
                      <a16:colId xmlns:a16="http://schemas.microsoft.com/office/drawing/2014/main" val="4263625"/>
                    </a:ext>
                  </a:extLst>
                </a:gridCol>
                <a:gridCol w="2435622">
                  <a:extLst>
                    <a:ext uri="{9D8B030D-6E8A-4147-A177-3AD203B41FA5}">
                      <a16:colId xmlns:a16="http://schemas.microsoft.com/office/drawing/2014/main" val="2617998669"/>
                    </a:ext>
                  </a:extLst>
                </a:gridCol>
                <a:gridCol w="817880">
                  <a:extLst>
                    <a:ext uri="{9D8B030D-6E8A-4147-A177-3AD203B41FA5}">
                      <a16:colId xmlns:a16="http://schemas.microsoft.com/office/drawing/2014/main" val="352458944"/>
                    </a:ext>
                  </a:extLst>
                </a:gridCol>
                <a:gridCol w="774615">
                  <a:extLst>
                    <a:ext uri="{9D8B030D-6E8A-4147-A177-3AD203B41FA5}">
                      <a16:colId xmlns:a16="http://schemas.microsoft.com/office/drawing/2014/main" val="2537076022"/>
                    </a:ext>
                  </a:extLst>
                </a:gridCol>
                <a:gridCol w="1263719">
                  <a:extLst>
                    <a:ext uri="{9D8B030D-6E8A-4147-A177-3AD203B41FA5}">
                      <a16:colId xmlns:a16="http://schemas.microsoft.com/office/drawing/2014/main" val="78454244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ene Expression Assay ID or Sequence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e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uencher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es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78426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t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999634_gH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93506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x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1053049_s1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830749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nog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2387400_g1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107021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f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358836_m1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21435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n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360700_g1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 of interest</a:t>
                      </a:r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336620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x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236830_m1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 of interest</a:t>
                      </a:r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372978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f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4419852_s1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 of interest</a:t>
                      </a:r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502592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kx6.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232355_m1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713126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cap="all" baseline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fB</a:t>
                      </a:r>
                      <a:endParaRPr lang="en-CA" sz="1000" b="0" i="1" u="none" strike="noStrike" cap="all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0534343_s1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19614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CA" sz="1000" b="0" i="1" u="none" strike="noStrike" cap="all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01060665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686092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99999905_m1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lang="en-DE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342713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wd_rtT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nl-NL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 CCT GCC AAT CGA GAT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igned by Primer Express 3.0 of 7500 Fast Real Time PCR System from Applied Biosystem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717172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_rtT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 ATG ACT CGC CTT CC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DE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DE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DE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0639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tTA Probe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GGCATCATACCCACTCCTGCCC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-MGB</a:t>
                      </a:r>
                      <a:endParaRPr lang="en-C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R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718965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158E65F-8697-FA7F-D0F4-B1CC796EE3D7}"/>
              </a:ext>
            </a:extLst>
          </p:cNvPr>
          <p:cNvSpPr txBox="1"/>
          <p:nvPr/>
        </p:nvSpPr>
        <p:spPr>
          <a:xfrm>
            <a:off x="236307" y="6052737"/>
            <a:ext cx="36781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: List of qPCR primers used.  </a:t>
            </a:r>
            <a:endParaRPr lang="en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90976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067FB0B-5A8F-7069-7EB9-A17521FFAF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3242142"/>
              </p:ext>
            </p:extLst>
          </p:nvPr>
        </p:nvGraphicFramePr>
        <p:xfrm>
          <a:off x="389811" y="420612"/>
          <a:ext cx="5092065" cy="4079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5492">
                  <a:extLst>
                    <a:ext uri="{9D8B030D-6E8A-4147-A177-3AD203B41FA5}">
                      <a16:colId xmlns:a16="http://schemas.microsoft.com/office/drawing/2014/main" val="4263625"/>
                    </a:ext>
                  </a:extLst>
                </a:gridCol>
                <a:gridCol w="3124518">
                  <a:extLst>
                    <a:ext uri="{9D8B030D-6E8A-4147-A177-3AD203B41FA5}">
                      <a16:colId xmlns:a16="http://schemas.microsoft.com/office/drawing/2014/main" val="2617998669"/>
                    </a:ext>
                  </a:extLst>
                </a:gridCol>
                <a:gridCol w="1202055">
                  <a:extLst>
                    <a:ext uri="{9D8B030D-6E8A-4147-A177-3AD203B41FA5}">
                      <a16:colId xmlns:a16="http://schemas.microsoft.com/office/drawing/2014/main" val="301522738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, Catalog Number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es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78426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T4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, sc8629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93506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NOG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ling Technologies, 4903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830749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TA4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, sc788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21435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X2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w England Biolabs, 3579S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336620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N3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 Aldrich, AB5684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 of interes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372978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X1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</a:t>
                      </a:r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isher, PA5-84405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 of interes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468051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FA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, ab26405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 of interes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502592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KX6.1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velopmental Studies Hybridoma Bank, F55A12-S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713126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ulin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ko</a:t>
                      </a:r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A0564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686092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peptide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ling Technologies, 4593S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3427133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4315947-D7FD-1AD7-3AB3-915C5BD215F1}"/>
              </a:ext>
            </a:extLst>
          </p:cNvPr>
          <p:cNvSpPr txBox="1"/>
          <p:nvPr/>
        </p:nvSpPr>
        <p:spPr>
          <a:xfrm>
            <a:off x="297951" y="4532162"/>
            <a:ext cx="43459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: List of primary antibodies used.  </a:t>
            </a:r>
            <a:endParaRPr lang="en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86655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067FB0B-5A8F-7069-7EB9-A17521FFAF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9900125"/>
              </p:ext>
            </p:extLst>
          </p:nvPr>
        </p:nvGraphicFramePr>
        <p:xfrm>
          <a:off x="403258" y="386993"/>
          <a:ext cx="3641090" cy="3337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17868">
                  <a:extLst>
                    <a:ext uri="{9D8B030D-6E8A-4147-A177-3AD203B41FA5}">
                      <a16:colId xmlns:a16="http://schemas.microsoft.com/office/drawing/2014/main" val="4263625"/>
                    </a:ext>
                  </a:extLst>
                </a:gridCol>
                <a:gridCol w="1078230">
                  <a:extLst>
                    <a:ext uri="{9D8B030D-6E8A-4147-A177-3AD203B41FA5}">
                      <a16:colId xmlns:a16="http://schemas.microsoft.com/office/drawing/2014/main" val="2617998669"/>
                    </a:ext>
                  </a:extLst>
                </a:gridCol>
                <a:gridCol w="1844992">
                  <a:extLst>
                    <a:ext uri="{9D8B030D-6E8A-4147-A177-3AD203B41FA5}">
                      <a16:colId xmlns:a16="http://schemas.microsoft.com/office/drawing/2014/main" val="361966264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gent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centration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, Catalog Number</a:t>
                      </a:r>
                      <a:endParaRPr lang="en-DE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78426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C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.0 m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l Roth, 3957.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93506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l</a:t>
                      </a:r>
                      <a:endParaRPr lang="en-C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 m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l Roth, 6781.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830749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l</a:t>
                      </a:r>
                      <a:r>
                        <a:rPr lang="en-CA" sz="1000" b="0" i="0" u="none" strike="noStrike" baseline="-7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m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 Aldrich, 1209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21435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Cl</a:t>
                      </a:r>
                      <a:r>
                        <a:rPr lang="en-CA" sz="1000" b="0" i="0" u="none" strike="noStrike" baseline="-7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m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va</a:t>
                      </a: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830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336620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HCO</a:t>
                      </a:r>
                      <a:r>
                        <a:rPr lang="en-CA" sz="1000" b="0" i="0" u="none" strike="noStrike" baseline="-7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 m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 Aldrich, S576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372978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0 m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 Aldrich, H403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468051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, A957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502592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co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m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a, G752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7131262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4315947-D7FD-1AD7-3AB3-915C5BD215F1}"/>
              </a:ext>
            </a:extLst>
          </p:cNvPr>
          <p:cNvSpPr txBox="1"/>
          <p:nvPr/>
        </p:nvSpPr>
        <p:spPr>
          <a:xfrm>
            <a:off x="297950" y="3831518"/>
            <a:ext cx="53309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3: Recipe for </a:t>
            </a:r>
            <a:r>
              <a:rPr lang="en-US" sz="1100" b="1" spc="-1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β-Krebs buffer.</a:t>
            </a:r>
            <a:r>
              <a:rPr lang="en-US" sz="1100" spc="-1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0468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9228</TotalTime>
  <Words>802</Words>
  <Application>Microsoft Macintosh PowerPoint</Application>
  <PresentationFormat>On-screen Show (4:3)</PresentationFormat>
  <Paragraphs>137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iramy Jeyagaran</dc:creator>
  <cp:lastModifiedBy>Katja Schenke-Layland</cp:lastModifiedBy>
  <cp:revision>414</cp:revision>
  <cp:lastPrinted>2023-11-08T11:13:52Z</cp:lastPrinted>
  <dcterms:created xsi:type="dcterms:W3CDTF">2023-08-01T21:17:50Z</dcterms:created>
  <dcterms:modified xsi:type="dcterms:W3CDTF">2024-04-26T17:12:41Z</dcterms:modified>
</cp:coreProperties>
</file>